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2" r:id="rId2"/>
  </p:sldIdLst>
  <p:sldSz cx="6246813" cy="8407400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99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2246" autoAdjust="0"/>
    <p:restoredTop sz="91726" autoAdjust="0"/>
  </p:normalViewPr>
  <p:slideViewPr>
    <p:cSldViewPr>
      <p:cViewPr>
        <p:scale>
          <a:sx n="100" d="100"/>
          <a:sy n="100" d="100"/>
        </p:scale>
        <p:origin x="-1596" y="-72"/>
      </p:cViewPr>
      <p:guideLst>
        <p:guide orient="horz" pos="2648"/>
        <p:guide pos="19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570057-FBE6-4955-B0BC-E63911DF14E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03D69A-890B-4EC1-AAFC-194F263353E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226317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4955AB-6544-408B-A233-E8A15C698EAB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92313" y="739775"/>
            <a:ext cx="27511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4DAD05-CFF1-44BE-89B4-795D6AEB849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128792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>
          <a:xfrm>
            <a:off x="1992313" y="739775"/>
            <a:ext cx="2751137" cy="3702050"/>
          </a:xfrm>
        </p:spPr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4DAD05-CFF1-44BE-89B4-795D6AEB849E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68512" y="2611744"/>
            <a:ext cx="5309791" cy="180214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37022" y="4764193"/>
            <a:ext cx="4372769" cy="21485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094125" y="412587"/>
            <a:ext cx="959796" cy="8794686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13651" y="412587"/>
            <a:ext cx="2776361" cy="8794686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3456" y="5402535"/>
            <a:ext cx="5309791" cy="166980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3456" y="3563416"/>
            <a:ext cx="5309791" cy="183911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13651" y="2405452"/>
            <a:ext cx="1867537" cy="68018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85301" y="2405452"/>
            <a:ext cx="1868621" cy="68018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2341" y="1881935"/>
            <a:ext cx="2760094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12341" y="2666236"/>
            <a:ext cx="2760094" cy="48439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173296" y="1881935"/>
            <a:ext cx="2761178" cy="7843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173296" y="2666236"/>
            <a:ext cx="2761178" cy="484398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12341" y="334739"/>
            <a:ext cx="2055158" cy="142458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442330" y="334742"/>
            <a:ext cx="3492142" cy="71754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12341" y="1759327"/>
            <a:ext cx="2055158" cy="575089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24420" y="5885181"/>
            <a:ext cx="3748088" cy="69477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24420" y="751217"/>
            <a:ext cx="3748088" cy="5044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24420" y="6579960"/>
            <a:ext cx="3748088" cy="9867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12341" y="336686"/>
            <a:ext cx="5622132" cy="1401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12341" y="1961729"/>
            <a:ext cx="5622132" cy="55484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12340" y="7792415"/>
            <a:ext cx="1457590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AAEA9-BCDC-4C9D-B93B-47AE6AAF87A4}" type="datetimeFigureOut">
              <a:rPr kumimoji="1" lang="ja-JP" altLang="en-US" smtClean="0"/>
              <a:pPr/>
              <a:t>2013/2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134329" y="7792415"/>
            <a:ext cx="1978157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476884" y="7792415"/>
            <a:ext cx="1457590" cy="4476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08DFF-E5F5-43F4-BF61-3B51BB1D8B0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テキスト ボックス 110"/>
          <p:cNvSpPr txBox="1"/>
          <p:nvPr/>
        </p:nvSpPr>
        <p:spPr>
          <a:xfrm>
            <a:off x="171078" y="171252"/>
            <a:ext cx="2481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mtClean="0"/>
              <a:t>Supplementary </a:t>
            </a:r>
            <a:r>
              <a:rPr kumimoji="1" lang="en-US" altLang="ja-JP" smtClean="0"/>
              <a:t>Figure 3.</a:t>
            </a:r>
            <a:endParaRPr kumimoji="1" lang="ja-JP" altLang="en-US" dirty="0"/>
          </a:p>
        </p:txBody>
      </p:sp>
      <p:grpSp>
        <p:nvGrpSpPr>
          <p:cNvPr id="227" name="グループ化 226"/>
          <p:cNvGrpSpPr/>
          <p:nvPr/>
        </p:nvGrpSpPr>
        <p:grpSpPr>
          <a:xfrm>
            <a:off x="1323206" y="603300"/>
            <a:ext cx="3116720" cy="2063012"/>
            <a:chOff x="6686" y="2376144"/>
            <a:chExt cx="3116720" cy="2063012"/>
          </a:xfrm>
        </p:grpSpPr>
        <p:grpSp>
          <p:nvGrpSpPr>
            <p:cNvPr id="215" name="グループ化 214"/>
            <p:cNvGrpSpPr/>
            <p:nvPr/>
          </p:nvGrpSpPr>
          <p:grpSpPr>
            <a:xfrm>
              <a:off x="6686" y="2376144"/>
              <a:ext cx="3116720" cy="2063012"/>
              <a:chOff x="6686" y="2263218"/>
              <a:chExt cx="3116720" cy="2063012"/>
            </a:xfrm>
          </p:grpSpPr>
          <p:pic>
            <p:nvPicPr>
              <p:cNvPr id="1044" name="Picture 20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94307" y="2475508"/>
                <a:ext cx="743943" cy="7439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3" name="Picture 19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857254" y="2475508"/>
                <a:ext cx="743942" cy="7439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53" name="テキスト ボックス 3"/>
              <p:cNvSpPr txBox="1"/>
              <p:nvPr/>
            </p:nvSpPr>
            <p:spPr>
              <a:xfrm>
                <a:off x="1618197" y="2278241"/>
                <a:ext cx="740217" cy="217523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pPr algn="ctr"/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nucleus</a:t>
                </a:r>
                <a:endParaRPr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テキスト ボックス 4"/>
              <p:cNvSpPr txBox="1"/>
              <p:nvPr/>
            </p:nvSpPr>
            <p:spPr>
              <a:xfrm>
                <a:off x="6686" y="2263218"/>
                <a:ext cx="1076924" cy="217523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CREB /p-CREB</a:t>
                </a:r>
                <a:endParaRPr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テキスト ボックス 5"/>
              <p:cNvSpPr txBox="1"/>
              <p:nvPr/>
            </p:nvSpPr>
            <p:spPr>
              <a:xfrm>
                <a:off x="921233" y="2280586"/>
                <a:ext cx="627155" cy="217523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pPr algn="ctr"/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CTF</a:t>
                </a:r>
                <a:endParaRPr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テキスト ボックス 6"/>
              <p:cNvSpPr txBox="1"/>
              <p:nvPr/>
            </p:nvSpPr>
            <p:spPr>
              <a:xfrm>
                <a:off x="2416071" y="2278241"/>
                <a:ext cx="639101" cy="217523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pPr algn="ctr"/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merge</a:t>
                </a:r>
                <a:endParaRPr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" name="テキスト ボックス 3"/>
              <p:cNvSpPr txBox="1"/>
              <p:nvPr/>
            </p:nvSpPr>
            <p:spPr>
              <a:xfrm>
                <a:off x="470816" y="3987676"/>
                <a:ext cx="2325560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PC12</a:t>
                </a:r>
                <a:r>
                  <a:rPr lang="ja-JP" altLang="en-US" sz="800" dirty="0" smtClean="0">
                    <a:latin typeface="Arial" pitchFamily="34" charset="0"/>
                    <a:cs typeface="Arial" pitchFamily="34" charset="0"/>
                  </a:rPr>
                  <a:t>　</a:t>
                </a:r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transient expression</a:t>
                </a:r>
                <a:r>
                  <a:rPr lang="ja-JP" altLang="en-US" sz="800" dirty="0" smtClean="0">
                    <a:latin typeface="Arial" pitchFamily="34" charset="0"/>
                    <a:cs typeface="Arial" pitchFamily="34" charset="0"/>
                  </a:rPr>
                  <a:t>　 </a:t>
                </a:r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rCTF-Q13-NES</a:t>
                </a:r>
                <a:r>
                  <a:rPr lang="ja-JP" altLang="en-US" sz="800" dirty="0" smtClean="0">
                    <a:latin typeface="Arial" pitchFamily="34" charset="0"/>
                    <a:cs typeface="Arial" pitchFamily="34" charset="0"/>
                  </a:rPr>
                  <a:t>　</a:t>
                </a:r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(48hours after </a:t>
                </a:r>
                <a:r>
                  <a:rPr lang="en-US" altLang="ja-JP" sz="800" dirty="0" err="1" smtClean="0">
                    <a:latin typeface="Arial" pitchFamily="34" charset="0"/>
                    <a:cs typeface="Arial" pitchFamily="34" charset="0"/>
                  </a:rPr>
                  <a:t>transfection</a:t>
                </a:r>
                <a:r>
                  <a:rPr lang="en-US" altLang="ja-JP" sz="8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2380939" y="2475508"/>
                <a:ext cx="742467" cy="7466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1619661" y="2475508"/>
                <a:ext cx="742467" cy="7466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36" name="Picture 12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2380939" y="3241050"/>
                <a:ext cx="742467" cy="7466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38" name="Picture 14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97105" y="3241050"/>
                <a:ext cx="742467" cy="7466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39" name="Picture 15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858383" y="3241050"/>
                <a:ext cx="742467" cy="7466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40" name="Picture 16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619661" y="3241050"/>
                <a:ext cx="742467" cy="7466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0" name="テキスト ボックス 29"/>
              <p:cNvSpPr txBox="1"/>
              <p:nvPr/>
            </p:nvSpPr>
            <p:spPr>
              <a:xfrm>
                <a:off x="1467222" y="3051572"/>
                <a:ext cx="1004732" cy="21752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pPr algn="ctr"/>
                <a:r>
                  <a:rPr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Hoechst 33258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34954" y="3057364"/>
                <a:ext cx="784196" cy="21023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REB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671012" y="3046809"/>
                <a:ext cx="602760" cy="21023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pPr algn="ctr"/>
                <a:r>
                  <a:rPr lang="en-US" altLang="ja-JP" sz="800" dirty="0" err="1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yc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>
                <a:off x="2297166" y="3062127"/>
                <a:ext cx="561571" cy="21023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erge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テキスト ボックス 210"/>
              <p:cNvSpPr txBox="1"/>
              <p:nvPr/>
            </p:nvSpPr>
            <p:spPr>
              <a:xfrm>
                <a:off x="1459330" y="3815082"/>
                <a:ext cx="1004733" cy="21752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pPr algn="ctr"/>
                <a:r>
                  <a:rPr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Hoechst 33258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テキスト ボックス 211"/>
              <p:cNvSpPr txBox="1"/>
              <p:nvPr/>
            </p:nvSpPr>
            <p:spPr>
              <a:xfrm>
                <a:off x="27062" y="3820875"/>
                <a:ext cx="784196" cy="21752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p-CREB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テキスト ボックス 212"/>
              <p:cNvSpPr txBox="1"/>
              <p:nvPr/>
            </p:nvSpPr>
            <p:spPr>
              <a:xfrm>
                <a:off x="663120" y="3810319"/>
                <a:ext cx="602761" cy="21023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pPr algn="ctr"/>
                <a:r>
                  <a:rPr lang="en-US" altLang="ja-JP" sz="800" dirty="0" err="1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yc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テキスト ボックス 213"/>
              <p:cNvSpPr txBox="1"/>
              <p:nvPr/>
            </p:nvSpPr>
            <p:spPr>
              <a:xfrm>
                <a:off x="2289274" y="3825637"/>
                <a:ext cx="561571" cy="210232"/>
              </a:xfrm>
              <a:prstGeom prst="rect">
                <a:avLst/>
              </a:prstGeom>
              <a:noFill/>
            </p:spPr>
            <p:txBody>
              <a:bodyPr wrap="square" lIns="93497" tIns="46749" rIns="93497" bIns="46749" rtlCol="0">
                <a:spAutoFit/>
              </a:bodyPr>
              <a:lstStyle/>
              <a:p>
                <a:r>
                  <a:rPr lang="en-US" altLang="ja-JP" sz="8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merge</a:t>
                </a:r>
                <a:endParaRPr lang="ja-JP" altLang="en-US" sz="8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46" name="グループ化 145"/>
            <p:cNvGrpSpPr/>
            <p:nvPr/>
          </p:nvGrpSpPr>
          <p:grpSpPr>
            <a:xfrm>
              <a:off x="976046" y="2727751"/>
              <a:ext cx="559265" cy="376277"/>
              <a:chOff x="976046" y="2727751"/>
              <a:chExt cx="559265" cy="376277"/>
            </a:xfrm>
          </p:grpSpPr>
          <p:sp>
            <p:nvSpPr>
              <p:cNvPr id="139" name="右矢印 138"/>
              <p:cNvSpPr/>
              <p:nvPr/>
            </p:nvSpPr>
            <p:spPr>
              <a:xfrm rot="6582523">
                <a:off x="955746" y="2932701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右矢印 139"/>
              <p:cNvSpPr/>
              <p:nvPr/>
            </p:nvSpPr>
            <p:spPr>
              <a:xfrm rot="6582523">
                <a:off x="1087857" y="3040424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右矢印 140"/>
              <p:cNvSpPr/>
              <p:nvPr/>
            </p:nvSpPr>
            <p:spPr>
              <a:xfrm rot="6582523">
                <a:off x="1224730" y="2748051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右矢印 141"/>
              <p:cNvSpPr/>
              <p:nvPr/>
            </p:nvSpPr>
            <p:spPr>
              <a:xfrm rot="6582523">
                <a:off x="1471707" y="2844026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47" name="グループ化 146"/>
            <p:cNvGrpSpPr/>
            <p:nvPr/>
          </p:nvGrpSpPr>
          <p:grpSpPr>
            <a:xfrm>
              <a:off x="2494382" y="2732009"/>
              <a:ext cx="559265" cy="376277"/>
              <a:chOff x="976046" y="2727751"/>
              <a:chExt cx="559265" cy="376277"/>
            </a:xfrm>
          </p:grpSpPr>
          <p:sp>
            <p:nvSpPr>
              <p:cNvPr id="148" name="右矢印 147"/>
              <p:cNvSpPr/>
              <p:nvPr/>
            </p:nvSpPr>
            <p:spPr>
              <a:xfrm rot="6582523">
                <a:off x="955746" y="2932701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9" name="右矢印 148"/>
              <p:cNvSpPr/>
              <p:nvPr/>
            </p:nvSpPr>
            <p:spPr>
              <a:xfrm rot="6582523">
                <a:off x="1087857" y="3040424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右矢印 149"/>
              <p:cNvSpPr/>
              <p:nvPr/>
            </p:nvSpPr>
            <p:spPr>
              <a:xfrm rot="6582523">
                <a:off x="1224730" y="2748051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右矢印 150"/>
              <p:cNvSpPr/>
              <p:nvPr/>
            </p:nvSpPr>
            <p:spPr>
              <a:xfrm rot="6582523">
                <a:off x="1471707" y="2844026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52" name="グループ化 151"/>
            <p:cNvGrpSpPr/>
            <p:nvPr/>
          </p:nvGrpSpPr>
          <p:grpSpPr>
            <a:xfrm>
              <a:off x="207371" y="2732009"/>
              <a:ext cx="559265" cy="376277"/>
              <a:chOff x="976046" y="2727751"/>
              <a:chExt cx="559265" cy="376277"/>
            </a:xfrm>
          </p:grpSpPr>
          <p:sp>
            <p:nvSpPr>
              <p:cNvPr id="153" name="右矢印 152"/>
              <p:cNvSpPr/>
              <p:nvPr/>
            </p:nvSpPr>
            <p:spPr>
              <a:xfrm rot="6582523">
                <a:off x="955746" y="2932701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" name="右矢印 153"/>
              <p:cNvSpPr/>
              <p:nvPr/>
            </p:nvSpPr>
            <p:spPr>
              <a:xfrm rot="6582523">
                <a:off x="1087857" y="3040424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5" name="右矢印 154"/>
              <p:cNvSpPr/>
              <p:nvPr/>
            </p:nvSpPr>
            <p:spPr>
              <a:xfrm rot="6582523">
                <a:off x="1224730" y="2748051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右矢印 156"/>
              <p:cNvSpPr/>
              <p:nvPr/>
            </p:nvSpPr>
            <p:spPr>
              <a:xfrm rot="6582523">
                <a:off x="1471707" y="2844026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18" name="グループ化 217"/>
            <p:cNvGrpSpPr/>
            <p:nvPr/>
          </p:nvGrpSpPr>
          <p:grpSpPr>
            <a:xfrm>
              <a:off x="1206355" y="3368258"/>
              <a:ext cx="261147" cy="499285"/>
              <a:chOff x="1206355" y="3368258"/>
              <a:chExt cx="261147" cy="499285"/>
            </a:xfrm>
          </p:grpSpPr>
          <p:sp>
            <p:nvSpPr>
              <p:cNvPr id="184" name="右矢印 183"/>
              <p:cNvSpPr/>
              <p:nvPr/>
            </p:nvSpPr>
            <p:spPr>
              <a:xfrm rot="6582523">
                <a:off x="1263403" y="3388558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" name="右矢印 208"/>
              <p:cNvSpPr/>
              <p:nvPr/>
            </p:nvSpPr>
            <p:spPr>
              <a:xfrm rot="6582523">
                <a:off x="1403898" y="3526672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右矢印 209"/>
              <p:cNvSpPr/>
              <p:nvPr/>
            </p:nvSpPr>
            <p:spPr>
              <a:xfrm rot="6582523">
                <a:off x="1186055" y="3803939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19" name="グループ化 218"/>
            <p:cNvGrpSpPr/>
            <p:nvPr/>
          </p:nvGrpSpPr>
          <p:grpSpPr>
            <a:xfrm>
              <a:off x="444940" y="3380668"/>
              <a:ext cx="261147" cy="499285"/>
              <a:chOff x="1206355" y="3368258"/>
              <a:chExt cx="261147" cy="499285"/>
            </a:xfrm>
          </p:grpSpPr>
          <p:sp>
            <p:nvSpPr>
              <p:cNvPr id="220" name="右矢印 219"/>
              <p:cNvSpPr/>
              <p:nvPr/>
            </p:nvSpPr>
            <p:spPr>
              <a:xfrm rot="6582523">
                <a:off x="1263403" y="3388558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" name="右矢印 220"/>
              <p:cNvSpPr/>
              <p:nvPr/>
            </p:nvSpPr>
            <p:spPr>
              <a:xfrm rot="6582523">
                <a:off x="1403898" y="3526672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" name="右矢印 221"/>
              <p:cNvSpPr/>
              <p:nvPr/>
            </p:nvSpPr>
            <p:spPr>
              <a:xfrm rot="6582523">
                <a:off x="1186055" y="3803939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23" name="グループ化 222"/>
            <p:cNvGrpSpPr/>
            <p:nvPr/>
          </p:nvGrpSpPr>
          <p:grpSpPr>
            <a:xfrm>
              <a:off x="2723005" y="3375328"/>
              <a:ext cx="261147" cy="499285"/>
              <a:chOff x="1206355" y="3368258"/>
              <a:chExt cx="261147" cy="499285"/>
            </a:xfrm>
          </p:grpSpPr>
          <p:sp>
            <p:nvSpPr>
              <p:cNvPr id="224" name="右矢印 223"/>
              <p:cNvSpPr/>
              <p:nvPr/>
            </p:nvSpPr>
            <p:spPr>
              <a:xfrm rot="6582523">
                <a:off x="1263403" y="3388558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" name="右矢印 224"/>
              <p:cNvSpPr/>
              <p:nvPr/>
            </p:nvSpPr>
            <p:spPr>
              <a:xfrm rot="6582523">
                <a:off x="1403898" y="3526672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" name="右矢印 225"/>
              <p:cNvSpPr/>
              <p:nvPr/>
            </p:nvSpPr>
            <p:spPr>
              <a:xfrm rot="6582523">
                <a:off x="1186055" y="3803939"/>
                <a:ext cx="83904" cy="43304"/>
              </a:xfrm>
              <a:prstGeom prst="rightArrow">
                <a:avLst/>
              </a:prstGeom>
              <a:solidFill>
                <a:schemeClr val="bg1"/>
              </a:solidFill>
              <a:ln w="6350">
                <a:solidFill>
                  <a:schemeClr val="bg1">
                    <a:lumMod val="9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57" name="テキスト ボックス 56"/>
          <p:cNvSpPr txBox="1"/>
          <p:nvPr/>
        </p:nvSpPr>
        <p:spPr>
          <a:xfrm>
            <a:off x="192055" y="2835548"/>
            <a:ext cx="57150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smtClean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800" b="1" dirty="0" smtClean="0">
                <a:latin typeface="Arial" pitchFamily="34" charset="0"/>
                <a:cs typeface="Arial" pitchFamily="34" charset="0"/>
              </a:rPr>
              <a:t>figure 3. Co-localization of CREB and p-CREB with </a:t>
            </a:r>
            <a:r>
              <a:rPr lang="en-US" sz="800" b="1" dirty="0" err="1" smtClean="0">
                <a:latin typeface="Arial" pitchFamily="34" charset="0"/>
                <a:cs typeface="Arial" pitchFamily="34" charset="0"/>
              </a:rPr>
              <a:t>cytoplasmic</a:t>
            </a:r>
            <a:r>
              <a:rPr lang="en-US" sz="800" b="1" dirty="0" smtClean="0">
                <a:latin typeface="Arial" pitchFamily="34" charset="0"/>
                <a:cs typeface="Arial" pitchFamily="34" charset="0"/>
              </a:rPr>
              <a:t> aggregates in </a:t>
            </a:r>
            <a:r>
              <a:rPr lang="en-US" altLang="ja-JP" sz="800" b="1" dirty="0" smtClean="0">
                <a:latin typeface="Arial" pitchFamily="34" charset="0"/>
                <a:ea typeface="ＭＳ 明朝" pitchFamily="17" charset="-128"/>
                <a:cs typeface="Arial" pitchFamily="34" charset="0"/>
              </a:rPr>
              <a:t>rCTF–Q13-NES expressing PC12 cells.</a:t>
            </a:r>
            <a:endParaRPr lang="en-US" sz="800" b="1" dirty="0" smtClean="0">
              <a:latin typeface="Arial" pitchFamily="34" charset="0"/>
              <a:cs typeface="Arial" pitchFamily="34" charset="0"/>
            </a:endParaRPr>
          </a:p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I</a:t>
            </a:r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PC12 cells over-expressing </a:t>
            </a:r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rCTF-Q13-NES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some of the 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cytoplasmic CTF aggregates </a:t>
            </a:r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co-localized 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with CREB (</a:t>
            </a:r>
            <a:r>
              <a:rPr lang="en-US" altLang="ja-JP" sz="800" i="1" dirty="0">
                <a:latin typeface="Arial" pitchFamily="34" charset="0"/>
                <a:cs typeface="Arial" pitchFamily="34" charset="0"/>
              </a:rPr>
              <a:t>upper row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) and p-CREB (</a:t>
            </a:r>
            <a:r>
              <a:rPr lang="en-US" altLang="ja-JP" sz="800" i="1" dirty="0">
                <a:latin typeface="Arial" pitchFamily="34" charset="0"/>
                <a:cs typeface="Arial" pitchFamily="34" charset="0"/>
              </a:rPr>
              <a:t>lower row</a:t>
            </a:r>
            <a:r>
              <a:rPr lang="en-US" altLang="ja-JP" sz="800" dirty="0" smtClean="0">
                <a:latin typeface="Arial" pitchFamily="34" charset="0"/>
                <a:cs typeface="Arial" pitchFamily="34" charset="0"/>
              </a:rPr>
              <a:t>) (co-localizations: arrows</a:t>
            </a:r>
            <a:r>
              <a:rPr lang="en-US" altLang="ja-JP" sz="800" dirty="0">
                <a:latin typeface="Arial" pitchFamily="34" charset="0"/>
                <a:cs typeface="Arial" pitchFamily="34" charset="0"/>
              </a:rPr>
              <a:t>).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26958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8575">
          <a:solidFill>
            <a:schemeClr val="tx1">
              <a:lumMod val="95000"/>
              <a:lumOff val="5000"/>
            </a:schemeClr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31</TotalTime>
  <Words>70</Words>
  <Application>Microsoft Office PowerPoint</Application>
  <PresentationFormat>ユーザー設定</PresentationFormat>
  <Paragraphs>17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Kinya Ishikawa</cp:lastModifiedBy>
  <cp:revision>409</cp:revision>
  <dcterms:created xsi:type="dcterms:W3CDTF">2011-11-22T17:33:32Z</dcterms:created>
  <dcterms:modified xsi:type="dcterms:W3CDTF">2013-02-09T22:38:20Z</dcterms:modified>
</cp:coreProperties>
</file>